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30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leeds365-my.sharepoint.com/personal/fbsjas_leeds_ac_uk/Documents/specialised%20ribosomes_J/data/paralog_bar_charts/RNASeq_tissues_pap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leeds365-my.sharepoint.com/personal/fbsjas_leeds_ac_uk/Documents/specialised%20ribosomes_J/data/paralog_bar_charts/RNASeq_tissues_pap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NASeq_tissues_paper!$Z$117</c:f>
              <c:strCache>
                <c:ptCount val="1"/>
                <c:pt idx="0">
                  <c:v>Testi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2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132-A94C-838E-0F031A773780}"/>
              </c:ext>
            </c:extLst>
          </c:dPt>
          <c:dPt>
            <c:idx val="3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132-A94C-838E-0F031A773780}"/>
              </c:ext>
            </c:extLst>
          </c:dPt>
          <c:dPt>
            <c:idx val="5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132-A94C-838E-0F031A773780}"/>
              </c:ext>
            </c:extLst>
          </c:dPt>
          <c:dPt>
            <c:idx val="6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132-A94C-838E-0F031A773780}"/>
              </c:ext>
            </c:extLst>
          </c:dPt>
          <c:dPt>
            <c:idx val="8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132-A94C-838E-0F031A773780}"/>
              </c:ext>
            </c:extLst>
          </c:dPt>
          <c:dPt>
            <c:idx val="11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132-A94C-838E-0F031A773780}"/>
              </c:ext>
            </c:extLst>
          </c:dPt>
          <c:dPt>
            <c:idx val="13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132-A94C-838E-0F031A773780}"/>
              </c:ext>
            </c:extLst>
          </c:dPt>
          <c:dPt>
            <c:idx val="15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132-A94C-838E-0F031A773780}"/>
              </c:ext>
            </c:extLst>
          </c:dPt>
          <c:dPt>
            <c:idx val="17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132-A94C-838E-0F031A773780}"/>
              </c:ext>
            </c:extLst>
          </c:dPt>
          <c:dPt>
            <c:idx val="19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132-A94C-838E-0F031A773780}"/>
              </c:ext>
            </c:extLst>
          </c:dPt>
          <c:cat>
            <c:multiLvlStrRef>
              <c:f>RNASeq_tissues_paper!$X$118:$Y$139</c:f>
              <c:multiLvlStrCache>
                <c:ptCount val="22"/>
                <c:lvl>
                  <c:pt idx="0">
                    <c:v>RpL22</c:v>
                  </c:pt>
                  <c:pt idx="1">
                    <c:v>RpL22-like</c:v>
                  </c:pt>
                  <c:pt idx="2">
                    <c:v>RpL37a</c:v>
                  </c:pt>
                  <c:pt idx="3">
                    <c:v>RpL37b</c:v>
                  </c:pt>
                  <c:pt idx="4">
                    <c:v>RpS19a</c:v>
                  </c:pt>
                  <c:pt idx="5">
                    <c:v>RpS19b</c:v>
                  </c:pt>
                  <c:pt idx="6">
                    <c:v>RpS10a</c:v>
                  </c:pt>
                  <c:pt idx="7">
                    <c:v>RpS10b-RB</c:v>
                  </c:pt>
                  <c:pt idx="8">
                    <c:v>RpS28a</c:v>
                  </c:pt>
                  <c:pt idx="9">
                    <c:v>RpS28b</c:v>
                  </c:pt>
                  <c:pt idx="10">
                    <c:v>RpS15Aa</c:v>
                  </c:pt>
                  <c:pt idx="11">
                    <c:v>RpS15Ab</c:v>
                  </c:pt>
                  <c:pt idx="12">
                    <c:v>RpL24</c:v>
                  </c:pt>
                  <c:pt idx="13">
                    <c:v>RpL24-like</c:v>
                  </c:pt>
                  <c:pt idx="14">
                    <c:v>RpL7</c:v>
                  </c:pt>
                  <c:pt idx="15">
                    <c:v>RpL7-like</c:v>
                  </c:pt>
                  <c:pt idx="16">
                    <c:v>RpLP0</c:v>
                  </c:pt>
                  <c:pt idx="17">
                    <c:v>RpLP0-like</c:v>
                  </c:pt>
                  <c:pt idx="18">
                    <c:v>RpS5a</c:v>
                  </c:pt>
                  <c:pt idx="19">
                    <c:v>RpS5b</c:v>
                  </c:pt>
                  <c:pt idx="20">
                    <c:v>RpL34a</c:v>
                  </c:pt>
                  <c:pt idx="21">
                    <c:v>RpL34b</c:v>
                  </c:pt>
                </c:lvl>
                <c:lvl>
                  <c:pt idx="0">
                    <c:v>RpL22/RpL22-like</c:v>
                  </c:pt>
                  <c:pt idx="2">
                    <c:v>RpL37a/b</c:v>
                  </c:pt>
                  <c:pt idx="4">
                    <c:v>RpS19a/b</c:v>
                  </c:pt>
                  <c:pt idx="6">
                    <c:v>RpS10a/b</c:v>
                  </c:pt>
                  <c:pt idx="8">
                    <c:v>RpS28a/b</c:v>
                  </c:pt>
                  <c:pt idx="10">
                    <c:v>RpS15Aa/b</c:v>
                  </c:pt>
                  <c:pt idx="12">
                    <c:v>RpL24/RpL24-like</c:v>
                  </c:pt>
                  <c:pt idx="14">
                    <c:v>RpL7/7-like</c:v>
                  </c:pt>
                  <c:pt idx="16">
                    <c:v>RpLP0/0-like</c:v>
                  </c:pt>
                  <c:pt idx="18">
                    <c:v>RpS5a/b</c:v>
                  </c:pt>
                  <c:pt idx="20">
                    <c:v>RPL34a/b</c:v>
                  </c:pt>
                </c:lvl>
              </c:multiLvlStrCache>
            </c:multiLvlStrRef>
          </c:cat>
          <c:val>
            <c:numRef>
              <c:f>RNASeq_tissues_paper!$Z$118:$Z$139</c:f>
              <c:numCache>
                <c:formatCode>General</c:formatCode>
                <c:ptCount val="22"/>
                <c:pt idx="0">
                  <c:v>61</c:v>
                </c:pt>
                <c:pt idx="1">
                  <c:v>73</c:v>
                </c:pt>
                <c:pt idx="2">
                  <c:v>104</c:v>
                </c:pt>
                <c:pt idx="3">
                  <c:v>103</c:v>
                </c:pt>
                <c:pt idx="4">
                  <c:v>203</c:v>
                </c:pt>
                <c:pt idx="5">
                  <c:v>182</c:v>
                </c:pt>
                <c:pt idx="6">
                  <c:v>207</c:v>
                </c:pt>
                <c:pt idx="7">
                  <c:v>259</c:v>
                </c:pt>
                <c:pt idx="8">
                  <c:v>42</c:v>
                </c:pt>
                <c:pt idx="9">
                  <c:v>148</c:v>
                </c:pt>
                <c:pt idx="10">
                  <c:v>207</c:v>
                </c:pt>
                <c:pt idx="11">
                  <c:v>17</c:v>
                </c:pt>
                <c:pt idx="12">
                  <c:v>505</c:v>
                </c:pt>
                <c:pt idx="13">
                  <c:v>96</c:v>
                </c:pt>
                <c:pt idx="14">
                  <c:v>123</c:v>
                </c:pt>
                <c:pt idx="15">
                  <c:v>37</c:v>
                </c:pt>
                <c:pt idx="16">
                  <c:v>373</c:v>
                </c:pt>
                <c:pt idx="17">
                  <c:v>24</c:v>
                </c:pt>
                <c:pt idx="18">
                  <c:v>162</c:v>
                </c:pt>
                <c:pt idx="19">
                  <c:v>84</c:v>
                </c:pt>
                <c:pt idx="20">
                  <c:v>142</c:v>
                </c:pt>
                <c:pt idx="21">
                  <c:v>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9132-A94C-838E-0F031A7737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623632"/>
        <c:axId val="146553152"/>
      </c:barChart>
      <c:catAx>
        <c:axId val="146623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146553152"/>
        <c:crosses val="autoZero"/>
        <c:auto val="1"/>
        <c:lblAlgn val="ctr"/>
        <c:lblOffset val="100"/>
        <c:noMultiLvlLbl val="0"/>
      </c:catAx>
      <c:valAx>
        <c:axId val="146553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146623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+mj-lt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NASeq_tissues_paper!$Z$141</c:f>
              <c:strCache>
                <c:ptCount val="1"/>
                <c:pt idx="0">
                  <c:v>Mated Ovary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2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6F4-D54C-8F7C-8D61C4AF7C7D}"/>
              </c:ext>
            </c:extLst>
          </c:dPt>
          <c:dPt>
            <c:idx val="11"/>
            <c:invertIfNegative val="0"/>
            <c:bubble3D val="0"/>
            <c:spPr>
              <a:solidFill>
                <a:srgbClr val="FB6001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6F4-D54C-8F7C-8D61C4AF7C7D}"/>
              </c:ext>
            </c:extLst>
          </c:dPt>
          <c:dPt>
            <c:idx val="13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6F4-D54C-8F7C-8D61C4AF7C7D}"/>
              </c:ext>
            </c:extLst>
          </c:dPt>
          <c:dPt>
            <c:idx val="15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6F4-D54C-8F7C-8D61C4AF7C7D}"/>
              </c:ext>
            </c:extLst>
          </c:dPt>
          <c:dPt>
            <c:idx val="17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6F4-D54C-8F7C-8D61C4AF7C7D}"/>
              </c:ext>
            </c:extLst>
          </c:dPt>
          <c:dPt>
            <c:idx val="19"/>
            <c:invertIfNegative val="0"/>
            <c:bubble3D val="0"/>
            <c:spPr>
              <a:solidFill>
                <a:srgbClr val="31A1AE"/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6F4-D54C-8F7C-8D61C4AF7C7D}"/>
              </c:ext>
            </c:extLst>
          </c:dPt>
          <c:cat>
            <c:multiLvlStrRef>
              <c:f>RNASeq_tissues_paper!$X$142:$Y$163</c:f>
              <c:multiLvlStrCache>
                <c:ptCount val="22"/>
                <c:lvl>
                  <c:pt idx="0">
                    <c:v>RpL22</c:v>
                  </c:pt>
                  <c:pt idx="1">
                    <c:v>RpL22-like</c:v>
                  </c:pt>
                  <c:pt idx="2">
                    <c:v>RpL37a</c:v>
                  </c:pt>
                  <c:pt idx="3">
                    <c:v>RpL37b</c:v>
                  </c:pt>
                  <c:pt idx="4">
                    <c:v>RpS19a</c:v>
                  </c:pt>
                  <c:pt idx="5">
                    <c:v>RpS19b</c:v>
                  </c:pt>
                  <c:pt idx="6">
                    <c:v>RpS10a</c:v>
                  </c:pt>
                  <c:pt idx="7">
                    <c:v>RpS10b-RB</c:v>
                  </c:pt>
                  <c:pt idx="8">
                    <c:v>RpS28a</c:v>
                  </c:pt>
                  <c:pt idx="9">
                    <c:v>RpS28b</c:v>
                  </c:pt>
                  <c:pt idx="10">
                    <c:v>RpS15Aa</c:v>
                  </c:pt>
                  <c:pt idx="11">
                    <c:v>RpS15Ab</c:v>
                  </c:pt>
                  <c:pt idx="12">
                    <c:v>RpL24</c:v>
                  </c:pt>
                  <c:pt idx="13">
                    <c:v>RpL24-like</c:v>
                  </c:pt>
                  <c:pt idx="14">
                    <c:v>RpL7</c:v>
                  </c:pt>
                  <c:pt idx="15">
                    <c:v>RpL7-like</c:v>
                  </c:pt>
                  <c:pt idx="16">
                    <c:v>RpLP0</c:v>
                  </c:pt>
                  <c:pt idx="17">
                    <c:v>RpLP0-like</c:v>
                  </c:pt>
                  <c:pt idx="18">
                    <c:v>RpS5a</c:v>
                  </c:pt>
                  <c:pt idx="19">
                    <c:v>RpS5b</c:v>
                  </c:pt>
                  <c:pt idx="20">
                    <c:v>RpL34a</c:v>
                  </c:pt>
                  <c:pt idx="21">
                    <c:v>RpL34b</c:v>
                  </c:pt>
                </c:lvl>
                <c:lvl>
                  <c:pt idx="0">
                    <c:v>RpL22/RpL22-like</c:v>
                  </c:pt>
                  <c:pt idx="2">
                    <c:v>RpL37a/b</c:v>
                  </c:pt>
                  <c:pt idx="4">
                    <c:v>RpS19a/b</c:v>
                  </c:pt>
                  <c:pt idx="6">
                    <c:v>RpS10a/b</c:v>
                  </c:pt>
                  <c:pt idx="8">
                    <c:v>RpS28a/b</c:v>
                  </c:pt>
                  <c:pt idx="10">
                    <c:v>RpS15Aa/b</c:v>
                  </c:pt>
                  <c:pt idx="12">
                    <c:v>RpL24/RpL24-like</c:v>
                  </c:pt>
                  <c:pt idx="14">
                    <c:v>RpL7/7-like</c:v>
                  </c:pt>
                  <c:pt idx="16">
                    <c:v>RpLP0/0-like</c:v>
                  </c:pt>
                  <c:pt idx="18">
                    <c:v>RpS5a/b</c:v>
                  </c:pt>
                  <c:pt idx="20">
                    <c:v>RPL34a/b</c:v>
                  </c:pt>
                </c:lvl>
              </c:multiLvlStrCache>
            </c:multiLvlStrRef>
          </c:cat>
          <c:val>
            <c:numRef>
              <c:f>RNASeq_tissues_paper!$Z$142:$Z$163</c:f>
              <c:numCache>
                <c:formatCode>General</c:formatCode>
                <c:ptCount val="22"/>
                <c:pt idx="0">
                  <c:v>280</c:v>
                </c:pt>
                <c:pt idx="1">
                  <c:v>1</c:v>
                </c:pt>
                <c:pt idx="2">
                  <c:v>300</c:v>
                </c:pt>
                <c:pt idx="3">
                  <c:v>0</c:v>
                </c:pt>
                <c:pt idx="4">
                  <c:v>304</c:v>
                </c:pt>
                <c:pt idx="5">
                  <c:v>0</c:v>
                </c:pt>
                <c:pt idx="6">
                  <c:v>47</c:v>
                </c:pt>
                <c:pt idx="7">
                  <c:v>317</c:v>
                </c:pt>
                <c:pt idx="8">
                  <c:v>0</c:v>
                </c:pt>
                <c:pt idx="9">
                  <c:v>156</c:v>
                </c:pt>
                <c:pt idx="10">
                  <c:v>533</c:v>
                </c:pt>
                <c:pt idx="11">
                  <c:v>24</c:v>
                </c:pt>
                <c:pt idx="12">
                  <c:v>414</c:v>
                </c:pt>
                <c:pt idx="13">
                  <c:v>101</c:v>
                </c:pt>
                <c:pt idx="14">
                  <c:v>220</c:v>
                </c:pt>
                <c:pt idx="15">
                  <c:v>141</c:v>
                </c:pt>
                <c:pt idx="16">
                  <c:v>349</c:v>
                </c:pt>
                <c:pt idx="17">
                  <c:v>101</c:v>
                </c:pt>
                <c:pt idx="18">
                  <c:v>116</c:v>
                </c:pt>
                <c:pt idx="19">
                  <c:v>318</c:v>
                </c:pt>
                <c:pt idx="20">
                  <c:v>161</c:v>
                </c:pt>
                <c:pt idx="21">
                  <c:v>3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6F4-D54C-8F7C-8D61C4AF7C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623632"/>
        <c:axId val="146553152"/>
      </c:barChart>
      <c:catAx>
        <c:axId val="146623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146553152"/>
        <c:crosses val="autoZero"/>
        <c:auto val="1"/>
        <c:lblAlgn val="ctr"/>
        <c:lblOffset val="100"/>
        <c:noMultiLvlLbl val="0"/>
      </c:catAx>
      <c:valAx>
        <c:axId val="146553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en-US"/>
          </a:p>
        </c:txPr>
        <c:crossAx val="146623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+mj-lt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5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A49C3B4-C86C-2C48-ADC0-6EC2E858CDA6}"/>
              </a:ext>
            </a:extLst>
          </p:cNvPr>
          <p:cNvSpPr txBox="1"/>
          <p:nvPr/>
        </p:nvSpPr>
        <p:spPr>
          <a:xfrm>
            <a:off x="6153961" y="89647"/>
            <a:ext cx="699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7</a:t>
            </a:r>
          </a:p>
          <a:p>
            <a:endParaRPr lang="en-US">
              <a:latin typeface="+mj-lt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104BC23-5FED-074D-BD5C-C93FAC867E39}"/>
              </a:ext>
            </a:extLst>
          </p:cNvPr>
          <p:cNvSpPr txBox="1"/>
          <p:nvPr/>
        </p:nvSpPr>
        <p:spPr>
          <a:xfrm>
            <a:off x="705" y="622380"/>
            <a:ext cx="3182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A</a:t>
            </a:r>
          </a:p>
          <a:p>
            <a:endParaRPr lang="en-US">
              <a:latin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72E8E25-F381-8641-A392-F3E7B414796A}"/>
              </a:ext>
            </a:extLst>
          </p:cNvPr>
          <p:cNvSpPr txBox="1"/>
          <p:nvPr/>
        </p:nvSpPr>
        <p:spPr>
          <a:xfrm>
            <a:off x="27787" y="4491335"/>
            <a:ext cx="3129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+mj-lt"/>
              </a:rPr>
              <a:t>B</a:t>
            </a:r>
          </a:p>
          <a:p>
            <a:endParaRPr lang="en-US">
              <a:latin typeface="+mj-lt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0AF8B84-D50A-E34F-8229-4195850C9C8C}"/>
              </a:ext>
            </a:extLst>
          </p:cNvPr>
          <p:cNvSpPr txBox="1"/>
          <p:nvPr/>
        </p:nvSpPr>
        <p:spPr>
          <a:xfrm>
            <a:off x="3107569" y="367526"/>
            <a:ext cx="693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>
                <a:latin typeface="+mj-lt"/>
              </a:rPr>
              <a:t>Test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F7C9F39-00A2-F748-AA3F-6A8825CA8A9C}"/>
              </a:ext>
            </a:extLst>
          </p:cNvPr>
          <p:cNvSpPr txBox="1"/>
          <p:nvPr/>
        </p:nvSpPr>
        <p:spPr>
          <a:xfrm>
            <a:off x="2847140" y="4768334"/>
            <a:ext cx="1388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>
                <a:latin typeface="+mj-lt"/>
              </a:rPr>
              <a:t>Mated Ovar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BD02E08-245F-204B-94CB-118750339517}"/>
              </a:ext>
            </a:extLst>
          </p:cNvPr>
          <p:cNvSpPr txBox="1"/>
          <p:nvPr/>
        </p:nvSpPr>
        <p:spPr>
          <a:xfrm rot="16200000">
            <a:off x="-794652" y="2010897"/>
            <a:ext cx="18437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>
                <a:latin typeface="+mj-lt"/>
              </a:rPr>
              <a:t>Transcript level (RPKM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9570E0-4D6C-E845-9652-90960D6CC5AE}"/>
              </a:ext>
            </a:extLst>
          </p:cNvPr>
          <p:cNvSpPr txBox="1"/>
          <p:nvPr/>
        </p:nvSpPr>
        <p:spPr>
          <a:xfrm rot="16200000">
            <a:off x="-836904" y="6165880"/>
            <a:ext cx="18437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>
                <a:latin typeface="+mj-lt"/>
              </a:rPr>
              <a:t>Transcript level (RPKM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21D6653-D56E-E540-A7D0-58F830C8B972}"/>
              </a:ext>
            </a:extLst>
          </p:cNvPr>
          <p:cNvGrpSpPr/>
          <p:nvPr/>
        </p:nvGrpSpPr>
        <p:grpSpPr>
          <a:xfrm>
            <a:off x="127204" y="632241"/>
            <a:ext cx="6847760" cy="3593798"/>
            <a:chOff x="238840" y="632241"/>
            <a:chExt cx="6785992" cy="3593798"/>
          </a:xfrm>
        </p:grpSpPr>
        <p:graphicFrame>
          <p:nvGraphicFramePr>
            <p:cNvPr id="17" name="Chart 16">
              <a:extLst>
                <a:ext uri="{FF2B5EF4-FFF2-40B4-BE49-F238E27FC236}">
                  <a16:creationId xmlns:a16="http://schemas.microsoft.com/office/drawing/2014/main" id="{CA2ED110-A159-964F-8606-F23B20D7B78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38840" y="632241"/>
            <a:ext cx="6785992" cy="35937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B45EEFA4-79FE-E44E-A027-F3505C48B8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73816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A6C8362D-ADD6-F64A-BA25-CDC98279B3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43905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F70B2281-EB93-154E-BEC3-203A35CE23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13994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A65BB731-09A4-144C-BE94-1A9F050B89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84083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55F78AA0-C0EE-1341-8028-EFFCBEEA64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4172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00E3EB5A-4852-2746-9704-686F1CA378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24261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EF6720DB-005B-8B4B-B899-CE0BCCBA4D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04616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ADDFF30A-5422-4F41-8D77-6212325F47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94350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77971481-CA1A-A248-8893-89CDCF47E4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64439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D10CB048-A227-F34F-8523-1C4B3DC7CC8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34528" y="778913"/>
              <a:ext cx="0" cy="265268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46E2C33B-275C-7941-AAB0-D63C128D632B}"/>
              </a:ext>
            </a:extLst>
          </p:cNvPr>
          <p:cNvGrpSpPr/>
          <p:nvPr/>
        </p:nvGrpSpPr>
        <p:grpSpPr>
          <a:xfrm>
            <a:off x="127204" y="5091499"/>
            <a:ext cx="6847760" cy="3425538"/>
            <a:chOff x="72008" y="5091499"/>
            <a:chExt cx="6902956" cy="3425538"/>
          </a:xfrm>
        </p:grpSpPr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675CAE0B-E551-214D-B40D-E352397673C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2008" y="5091499"/>
            <a:ext cx="6902956" cy="34255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25427FA-A722-584F-8561-0F0EDFB3AC2F}"/>
                </a:ext>
              </a:extLst>
            </p:cNvPr>
            <p:cNvGrpSpPr/>
            <p:nvPr/>
          </p:nvGrpSpPr>
          <p:grpSpPr>
            <a:xfrm>
              <a:off x="1008628" y="5137666"/>
              <a:ext cx="5239564" cy="2652681"/>
              <a:chOff x="1108554" y="5137666"/>
              <a:chExt cx="5130800" cy="2652681"/>
            </a:xfrm>
          </p:grpSpPr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788D0D33-A4EF-F54B-84A7-EDD1D09D89A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08554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FC6D561F-A680-A041-A11C-268029A0245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678643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8FFE90B2-3DCA-2E4B-9E42-7638AE611A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8732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05704CA6-5F20-F34C-8806-44774766E7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818821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85240D18-0E79-7547-B68F-19C5A557F10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88910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E30A1D76-B003-F048-A0F9-3B36BC2DF4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58999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91FC87CD-7CA2-8848-BBA0-2B986A2C077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239354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9ACFE298-F29E-6941-A0E3-8634FBE02E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29088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76E749CC-E208-9949-ADED-A4B5064FCF0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99177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D1CC7D8B-AEBA-1545-BE39-CD8CE02D1B2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669266" y="5137666"/>
                <a:ext cx="0" cy="2652681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" name="Rectangle 1">
            <a:extLst>
              <a:ext uri="{FF2B5EF4-FFF2-40B4-BE49-F238E27FC236}">
                <a16:creationId xmlns:a16="http://schemas.microsoft.com/office/drawing/2014/main" id="{89D8E10B-E8BB-0042-8D91-B07A635A37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650" y="8803206"/>
            <a:ext cx="6451520" cy="12157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 7: Relative levels of RP paralog pair mRNA according to RNA-Seq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RNA levels of RP paralogs in (A) testis and (B) mated ovary tissue. RNA-Seq data was extracted from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Min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mine.modencode.org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(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yn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mith et al. 2007) with data from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dENCOD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ject (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aveley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rooks et al. 2011, Brown,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ley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t al. 2014). Values are RPKMs. Testis enriched paralogs (orange), ovary enriched paralogs (turquoise).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4790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9338D3-8708-7A40-AEB8-A115C817E03C}"/>
              </a:ext>
            </a:extLst>
          </p:cNvPr>
          <p:cNvSpPr txBox="1"/>
          <p:nvPr/>
        </p:nvSpPr>
        <p:spPr>
          <a:xfrm>
            <a:off x="6153961" y="89647"/>
            <a:ext cx="6992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8</a:t>
            </a:r>
          </a:p>
          <a:p>
            <a:endParaRPr lang="en-US">
              <a:latin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21E1E13-4123-4B4C-9FCB-3E508A9C80AC}"/>
              </a:ext>
            </a:extLst>
          </p:cNvPr>
          <p:cNvSpPr txBox="1"/>
          <p:nvPr/>
        </p:nvSpPr>
        <p:spPr>
          <a:xfrm>
            <a:off x="103424" y="696025"/>
            <a:ext cx="3182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A</a:t>
            </a:r>
          </a:p>
          <a:p>
            <a:endParaRPr lang="en-US"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79A9CF-C36C-4A47-9BEC-D9D6E343E4C1}"/>
              </a:ext>
            </a:extLst>
          </p:cNvPr>
          <p:cNvSpPr txBox="1"/>
          <p:nvPr/>
        </p:nvSpPr>
        <p:spPr>
          <a:xfrm>
            <a:off x="2908173" y="602920"/>
            <a:ext cx="3129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+mj-lt"/>
              </a:rPr>
              <a:t>B</a:t>
            </a:r>
          </a:p>
          <a:p>
            <a:endParaRPr lang="en-US">
              <a:latin typeface="+mj-lt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E2D2EA1F-FE66-4C48-9A15-B726F1633D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4444" y="3753557"/>
            <a:ext cx="2176939" cy="252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4CA5F11-7888-9E47-8EC0-6198CE911D73}"/>
              </a:ext>
            </a:extLst>
          </p:cNvPr>
          <p:cNvSpPr txBox="1"/>
          <p:nvPr/>
        </p:nvSpPr>
        <p:spPr>
          <a:xfrm>
            <a:off x="103424" y="3347213"/>
            <a:ext cx="3080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C</a:t>
            </a:r>
          </a:p>
          <a:p>
            <a:endParaRPr lang="en-US">
              <a:latin typeface="+mj-lt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4DF5B0-5DCF-E94C-9842-57AACEFF7BE7}"/>
              </a:ext>
            </a:extLst>
          </p:cNvPr>
          <p:cNvSpPr txBox="1"/>
          <p:nvPr/>
        </p:nvSpPr>
        <p:spPr>
          <a:xfrm>
            <a:off x="2908173" y="3378057"/>
            <a:ext cx="3129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+mj-lt"/>
              </a:rPr>
              <a:t>D</a:t>
            </a:r>
          </a:p>
          <a:p>
            <a:endParaRPr lang="en-US">
              <a:latin typeface="+mj-lt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6ECC73E-75E0-4458-AF51-1A88A5DDF0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2042" y="823613"/>
            <a:ext cx="2191261" cy="2523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72390EC-293E-444A-8645-857021C058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522" y="823613"/>
            <a:ext cx="2344763" cy="252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61A0407-8F8E-4556-973C-D6CC16F66D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484" y="3737229"/>
            <a:ext cx="2188380" cy="25200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48B50AF-FA77-CA4F-9121-B466EF8AAC90}"/>
              </a:ext>
            </a:extLst>
          </p:cNvPr>
          <p:cNvSpPr/>
          <p:nvPr/>
        </p:nvSpPr>
        <p:spPr>
          <a:xfrm>
            <a:off x="103424" y="6679901"/>
            <a:ext cx="633984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 8: Little difference between composition of 80S and polysome ribosomes</a:t>
            </a:r>
            <a:endParaRPr lang="en-GB" sz="1100" b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olcano plots comparing proteins detected in the 80S and polysome fractions for (A) testis, (B) head, (C) ovary and (D) embryo tissue. Log</a:t>
            </a:r>
            <a:r>
              <a:rPr lang="en-US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ld-change cut off is 1.5 and p-value &lt;0.05. Enriched RPs are labelled.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6522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74</Words>
  <Application>Microsoft Macintosh PowerPoint</Application>
  <PresentationFormat>A4 Paper (210x297 mm)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4</cp:revision>
  <cp:lastPrinted>2021-04-23T12:48:59Z</cp:lastPrinted>
  <dcterms:created xsi:type="dcterms:W3CDTF">2019-05-17T07:50:07Z</dcterms:created>
  <dcterms:modified xsi:type="dcterms:W3CDTF">2021-05-22T13:36:42Z</dcterms:modified>
</cp:coreProperties>
</file>